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2" d="100"/>
          <a:sy n="102" d="100"/>
        </p:scale>
        <p:origin x="-19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98950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2544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32206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04948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8781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32952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74846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34795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96343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47901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7985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10879-E8D0-414E-BE9F-8346C5CF6553}" type="datetimeFigureOut">
              <a:rPr lang="pl-PL" smtClean="0"/>
              <a:t>2019-08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248E5-9ECC-4CA9-BDF5-FE45DABCAA3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02472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6" name="Picture 22" descr="C:\Users\IR_NP6\Desktop\Downloads\AAHLADRPerCP HISTOGRAM_3891468872022674188(1)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46275" y="4851559"/>
            <a:ext cx="2120900" cy="140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1589" y="6195475"/>
            <a:ext cx="14144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Prostokąt 12"/>
          <p:cNvSpPr/>
          <p:nvPr/>
        </p:nvSpPr>
        <p:spPr>
          <a:xfrm>
            <a:off x="5525142" y="481092"/>
            <a:ext cx="415010" cy="259838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pic>
        <p:nvPicPr>
          <p:cNvPr id="1026" name="Picture 2" descr="C:\Users\IR_NP6\Desktop\OPUSdopublikacji\fscssc CONTOUR_2424831359076704942.jpe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44624"/>
            <a:ext cx="2114550" cy="211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IR_NP6\Desktop\OPUSdopublikacji\doubletdiscrimination DOTPLOT_3709783706404901664.jpe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1839" y="44624"/>
            <a:ext cx="2200275" cy="2105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IR_NP6\Desktop\Downloads\AACD73APC HISTOGRAM_3695583831341449127(1)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007" y="3068961"/>
            <a:ext cx="2120900" cy="140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Strzałka w prawo 4"/>
          <p:cNvSpPr/>
          <p:nvPr/>
        </p:nvSpPr>
        <p:spPr>
          <a:xfrm>
            <a:off x="2555776" y="1097074"/>
            <a:ext cx="576063" cy="4571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102770" y="2397758"/>
            <a:ext cx="609600" cy="103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" name="Łącznik prosty ze strzałką 6"/>
          <p:cNvCxnSpPr/>
          <p:nvPr/>
        </p:nvCxnSpPr>
        <p:spPr>
          <a:xfrm>
            <a:off x="299795" y="4478663"/>
            <a:ext cx="1319877" cy="1032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1" name="Picture 7" descr="C:\Users\IR_NP6\Desktop\Downloads\AAISOFITC HISTOGRAM_1863023415743317464.jpg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4475" y="3079286"/>
            <a:ext cx="2120900" cy="140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IR_NP6\Desktop\Downloads\AAISOPE HISTOGRAM_7594487075117075330.jp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0150" y="3068961"/>
            <a:ext cx="2120900" cy="140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Nawias klamrowy zamykający 3"/>
          <p:cNvSpPr/>
          <p:nvPr/>
        </p:nvSpPr>
        <p:spPr>
          <a:xfrm rot="16200000">
            <a:off x="4306134" y="12027"/>
            <a:ext cx="288032" cy="5846485"/>
          </a:xfrm>
          <a:prstGeom prst="rightBrace">
            <a:avLst>
              <a:gd name="adj1" fmla="val 8333"/>
              <a:gd name="adj2" fmla="val 49318"/>
            </a:avLst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 dirty="0"/>
          </a:p>
        </p:txBody>
      </p:sp>
      <p:sp>
        <p:nvSpPr>
          <p:cNvPr id="8" name="pole tekstowe 7"/>
          <p:cNvSpPr txBox="1"/>
          <p:nvPr/>
        </p:nvSpPr>
        <p:spPr>
          <a:xfrm>
            <a:off x="1619672" y="433781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b="1" dirty="0" smtClean="0"/>
              <a:t>CD73</a:t>
            </a:r>
            <a:endParaRPr lang="pl-PL" b="1" dirty="0"/>
          </a:p>
        </p:txBody>
      </p:sp>
      <p:pic>
        <p:nvPicPr>
          <p:cNvPr id="1035" name="Picture 11" descr="C:\Users\IR_NP6\Desktop\Downloads\AACD19PE HISTOGRAM_4511112434599586430.jp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74" y="4832805"/>
            <a:ext cx="2120900" cy="140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624" y="6105186"/>
            <a:ext cx="1417169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8758" y="4351668"/>
            <a:ext cx="1405716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4899" y="4385164"/>
            <a:ext cx="1620485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Prostokąt 10"/>
          <p:cNvSpPr/>
          <p:nvPr/>
        </p:nvSpPr>
        <p:spPr>
          <a:xfrm>
            <a:off x="1668969" y="6089490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b="1" dirty="0" smtClean="0"/>
              <a:t>CD19</a:t>
            </a:r>
            <a:endParaRPr lang="pl-PL" b="1" dirty="0"/>
          </a:p>
        </p:txBody>
      </p:sp>
      <p:sp>
        <p:nvSpPr>
          <p:cNvPr id="12" name="Prostokąt 11"/>
          <p:cNvSpPr/>
          <p:nvPr/>
        </p:nvSpPr>
        <p:spPr>
          <a:xfrm>
            <a:off x="5510600" y="215516"/>
            <a:ext cx="429552" cy="192596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pic>
        <p:nvPicPr>
          <p:cNvPr id="1041" name="Picture 17" descr="C:\Users\IR_NP6\Desktop\Downloads\AACd34PeCy7 HISTOGRAM_6176133919630987724.jpg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9251" y="4848434"/>
            <a:ext cx="2120900" cy="140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2045" y="6136837"/>
            <a:ext cx="1412428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Prostokąt 14"/>
          <p:cNvSpPr/>
          <p:nvPr/>
        </p:nvSpPr>
        <p:spPr>
          <a:xfrm>
            <a:off x="3776279" y="6105186"/>
            <a:ext cx="68640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b="1" dirty="0" smtClean="0"/>
              <a:t>CD34</a:t>
            </a:r>
          </a:p>
          <a:p>
            <a:endParaRPr lang="pl-PL" b="1" dirty="0"/>
          </a:p>
        </p:txBody>
      </p:sp>
      <p:sp>
        <p:nvSpPr>
          <p:cNvPr id="17" name="pole tekstowe 16"/>
          <p:cNvSpPr txBox="1"/>
          <p:nvPr/>
        </p:nvSpPr>
        <p:spPr>
          <a:xfrm>
            <a:off x="5940152" y="142538"/>
            <a:ext cx="29556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 err="1"/>
              <a:t>c</a:t>
            </a:r>
            <a:r>
              <a:rPr lang="pl-PL" sz="1600" dirty="0" err="1" smtClean="0"/>
              <a:t>ells</a:t>
            </a:r>
            <a:r>
              <a:rPr lang="pl-PL" sz="1600" dirty="0" smtClean="0"/>
              <a:t>  </a:t>
            </a:r>
            <a:r>
              <a:rPr lang="pl-PL" sz="1600" dirty="0" err="1" smtClean="0"/>
              <a:t>stained</a:t>
            </a:r>
            <a:r>
              <a:rPr lang="pl-PL" sz="1600" dirty="0" smtClean="0"/>
              <a:t> with </a:t>
            </a:r>
            <a:r>
              <a:rPr lang="pl-PL" sz="1600" dirty="0" err="1" smtClean="0"/>
              <a:t>isotype</a:t>
            </a:r>
            <a:r>
              <a:rPr lang="pl-PL" sz="1600" dirty="0" smtClean="0"/>
              <a:t> </a:t>
            </a:r>
            <a:r>
              <a:rPr lang="pl-PL" sz="1600" dirty="0" err="1" smtClean="0"/>
              <a:t>control</a:t>
            </a:r>
            <a:endParaRPr lang="pl-PL" sz="1600" dirty="0"/>
          </a:p>
        </p:txBody>
      </p:sp>
      <p:sp>
        <p:nvSpPr>
          <p:cNvPr id="18" name="Prostokąt 17"/>
          <p:cNvSpPr/>
          <p:nvPr/>
        </p:nvSpPr>
        <p:spPr>
          <a:xfrm>
            <a:off x="5940152" y="481092"/>
            <a:ext cx="315733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/>
              <a:t>cells  stained with </a:t>
            </a:r>
            <a:r>
              <a:rPr lang="pl-PL" sz="1600" dirty="0" err="1" smtClean="0"/>
              <a:t>specific</a:t>
            </a:r>
            <a:r>
              <a:rPr lang="pl-PL" sz="1600" dirty="0" smtClean="0"/>
              <a:t> </a:t>
            </a:r>
            <a:r>
              <a:rPr lang="pl-PL" sz="1600" dirty="0" err="1" smtClean="0"/>
              <a:t>antibody</a:t>
            </a:r>
            <a:endParaRPr lang="en-US" sz="1600" dirty="0"/>
          </a:p>
        </p:txBody>
      </p:sp>
      <p:pic>
        <p:nvPicPr>
          <p:cNvPr id="1042" name="Picture 18" descr="C:\Users\IR_NP6\Desktop\Downloads\AACD45PE HISTOGRAM_4362741871124789724.jpg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5375" y="4864456"/>
            <a:ext cx="2120900" cy="140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6170189"/>
            <a:ext cx="14144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Prostokąt 18"/>
          <p:cNvSpPr/>
          <p:nvPr/>
        </p:nvSpPr>
        <p:spPr>
          <a:xfrm>
            <a:off x="5861472" y="6133437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b="1" dirty="0" smtClean="0"/>
              <a:t>CD45</a:t>
            </a:r>
            <a:endParaRPr lang="pl-PL" b="1" dirty="0"/>
          </a:p>
        </p:txBody>
      </p:sp>
      <p:sp>
        <p:nvSpPr>
          <p:cNvPr id="20" name="Prostokąt 19"/>
          <p:cNvSpPr/>
          <p:nvPr/>
        </p:nvSpPr>
        <p:spPr>
          <a:xfrm>
            <a:off x="8226052" y="6122841"/>
            <a:ext cx="8435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b="1" dirty="0" smtClean="0"/>
              <a:t>HLADR</a:t>
            </a:r>
            <a:endParaRPr lang="pl-PL" b="1" dirty="0"/>
          </a:p>
        </p:txBody>
      </p:sp>
      <p:sp>
        <p:nvSpPr>
          <p:cNvPr id="21" name="Prostokąt 20"/>
          <p:cNvSpPr/>
          <p:nvPr/>
        </p:nvSpPr>
        <p:spPr>
          <a:xfrm>
            <a:off x="3777882" y="4322758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b="1" dirty="0" smtClean="0"/>
              <a:t>CD90</a:t>
            </a:r>
            <a:endParaRPr lang="pl-PL" b="1" dirty="0"/>
          </a:p>
        </p:txBody>
      </p:sp>
      <p:sp>
        <p:nvSpPr>
          <p:cNvPr id="22" name="Prostokąt 21"/>
          <p:cNvSpPr/>
          <p:nvPr/>
        </p:nvSpPr>
        <p:spPr>
          <a:xfrm>
            <a:off x="6228648" y="4351668"/>
            <a:ext cx="801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b="1" dirty="0" smtClean="0"/>
              <a:t>CD105</a:t>
            </a:r>
            <a:endParaRPr lang="pl-PL" b="1" dirty="0"/>
          </a:p>
        </p:txBody>
      </p:sp>
    </p:spTree>
    <p:extLst>
      <p:ext uri="{BB962C8B-B14F-4D97-AF65-F5344CB8AC3E}">
        <p14:creationId xmlns:p14="http://schemas.microsoft.com/office/powerpoint/2010/main" val="116123711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17</Words>
  <Application>Microsoft Office PowerPoint</Application>
  <PresentationFormat>Pokaz na ekranie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Motyw pakietu Office</vt:lpstr>
      <vt:lpstr>Prezentacja programu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IR_NP6</dc:creator>
  <cp:lastModifiedBy>IR_NP6</cp:lastModifiedBy>
  <cp:revision>7</cp:revision>
  <dcterms:created xsi:type="dcterms:W3CDTF">2019-08-14T13:45:08Z</dcterms:created>
  <dcterms:modified xsi:type="dcterms:W3CDTF">2019-08-14T14:41:02Z</dcterms:modified>
</cp:coreProperties>
</file>